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77" d="100"/>
          <a:sy n="77" d="100"/>
        </p:scale>
        <p:origin x="224" y="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2784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0142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9730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0746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6254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1865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5826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1018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2884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361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7455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CAB6BC-8DF6-4F5C-B3B4-6F742DF5AF8F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5C6AF-A497-4070-A73A-459AF4ECFC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158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/>
          <a:srcRect l="12491" r="29766" b="3589"/>
          <a:stretch/>
        </p:blipFill>
        <p:spPr>
          <a:xfrm>
            <a:off x="679633" y="443697"/>
            <a:ext cx="2965783" cy="3448019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/>
          <a:srcRect l="12514" t="4464" b="7671"/>
          <a:stretch/>
        </p:blipFill>
        <p:spPr>
          <a:xfrm>
            <a:off x="3945110" y="471178"/>
            <a:ext cx="3445806" cy="3393055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/>
          <a:srcRect l="7749" t="14641" r="30138" b="2872"/>
          <a:stretch/>
        </p:blipFill>
        <p:spPr>
          <a:xfrm>
            <a:off x="7552764" y="833718"/>
            <a:ext cx="3160059" cy="2970263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5"/>
          <a:srcRect l="16141" b="7599"/>
          <a:stretch/>
        </p:blipFill>
        <p:spPr>
          <a:xfrm>
            <a:off x="763790" y="3908013"/>
            <a:ext cx="2989043" cy="2775311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6"/>
          <a:srcRect l="14067" t="16379" b="9216"/>
          <a:stretch/>
        </p:blipFill>
        <p:spPr>
          <a:xfrm>
            <a:off x="3996805" y="4069924"/>
            <a:ext cx="3355664" cy="2592712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7"/>
          <a:srcRect l="13458" t="12619" r="14127" b="4928"/>
          <a:stretch/>
        </p:blipFill>
        <p:spPr>
          <a:xfrm>
            <a:off x="7646426" y="3924564"/>
            <a:ext cx="2990199" cy="2742210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2631319" y="855791"/>
            <a:ext cx="1183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 Value NS</a:t>
            </a:r>
            <a:endParaRPr lang="de-DE" dirty="0"/>
          </a:p>
        </p:txBody>
      </p:sp>
      <p:sp>
        <p:nvSpPr>
          <p:cNvPr id="11" name="Textfeld 10"/>
          <p:cNvSpPr txBox="1"/>
          <p:nvPr/>
        </p:nvSpPr>
        <p:spPr>
          <a:xfrm>
            <a:off x="6254955" y="855791"/>
            <a:ext cx="1183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 Value NS</a:t>
            </a:r>
            <a:endParaRPr lang="de-DE" dirty="0"/>
          </a:p>
        </p:txBody>
      </p:sp>
      <p:sp>
        <p:nvSpPr>
          <p:cNvPr id="12" name="Textfeld 11"/>
          <p:cNvSpPr txBox="1"/>
          <p:nvPr/>
        </p:nvSpPr>
        <p:spPr>
          <a:xfrm>
            <a:off x="9529752" y="855791"/>
            <a:ext cx="1183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 Value N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2631319" y="4069234"/>
            <a:ext cx="1183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 Value NS</a:t>
            </a:r>
            <a:endParaRPr lang="de-DE" dirty="0"/>
          </a:p>
        </p:txBody>
      </p:sp>
      <p:sp>
        <p:nvSpPr>
          <p:cNvPr id="14" name="Textfeld 13"/>
          <p:cNvSpPr txBox="1"/>
          <p:nvPr/>
        </p:nvSpPr>
        <p:spPr>
          <a:xfrm>
            <a:off x="6254955" y="4069234"/>
            <a:ext cx="1183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 Value NS</a:t>
            </a:r>
            <a:endParaRPr lang="de-DE" dirty="0"/>
          </a:p>
        </p:txBody>
      </p:sp>
      <p:sp>
        <p:nvSpPr>
          <p:cNvPr id="15" name="Textfeld 14"/>
          <p:cNvSpPr txBox="1"/>
          <p:nvPr/>
        </p:nvSpPr>
        <p:spPr>
          <a:xfrm>
            <a:off x="9529752" y="4069234"/>
            <a:ext cx="1183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 Value NS</a:t>
            </a:r>
            <a:endParaRPr lang="de-DE" dirty="0"/>
          </a:p>
        </p:txBody>
      </p:sp>
      <p:sp>
        <p:nvSpPr>
          <p:cNvPr id="16" name="Textfeld 15"/>
          <p:cNvSpPr txBox="1"/>
          <p:nvPr/>
        </p:nvSpPr>
        <p:spPr>
          <a:xfrm rot="16200000">
            <a:off x="-1107387" y="1890344"/>
            <a:ext cx="28492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NMN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centrations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 (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823703" y="51594"/>
            <a:ext cx="32015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Filter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4410926" y="51594"/>
            <a:ext cx="29867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de-DE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Filter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7704060" y="51594"/>
            <a:ext cx="35189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unt &amp; </a:t>
            </a:r>
            <a:r>
              <a:rPr lang="de-DE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ar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end </a:t>
            </a:r>
            <a:r>
              <a:rPr lang="de-DE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HD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382468" y="6558525"/>
            <a:ext cx="556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2325876" y="6558525"/>
            <a:ext cx="7136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F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4668996" y="6554387"/>
            <a:ext cx="556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5668013" y="6554387"/>
            <a:ext cx="7136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F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8460134" y="6547388"/>
            <a:ext cx="556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9425897" y="6554387"/>
            <a:ext cx="7136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F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 rot="16200000">
            <a:off x="-758435" y="5027827"/>
            <a:ext cx="24067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MN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centrations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930600" y="70855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1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4211967" y="708556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7952028" y="70855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1c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930600" y="393105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211967" y="3931052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7952028" y="393105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166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2279286" y="1031252"/>
            <a:ext cx="699837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Refrain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cohol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cotine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ffeinated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verages</a:t>
            </a:r>
            <a:endParaRPr lang="de-DE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void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cyclic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depressants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f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ssible</a:t>
            </a:r>
            <a:endParaRPr lang="de-DE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4020622" y="3522609"/>
            <a:ext cx="35157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tructions</a:t>
            </a:r>
            <a:r>
              <a:rPr lang="de-DE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de-DE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HD</a:t>
            </a:r>
            <a:endParaRPr lang="de-DE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190267" y="48180"/>
            <a:ext cx="5176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structions</a:t>
            </a:r>
            <a:r>
              <a:rPr lang="de-DE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HD</a:t>
            </a:r>
            <a:endParaRPr lang="de-DE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Gerader Verbinder 28"/>
          <p:cNvCxnSpPr/>
          <p:nvPr/>
        </p:nvCxnSpPr>
        <p:spPr>
          <a:xfrm flipV="1">
            <a:off x="-86888" y="2782411"/>
            <a:ext cx="12192000" cy="1763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463406" y="4193843"/>
            <a:ext cx="10422505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de-DE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ite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mpling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2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alysis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smtClean="0">
                <a:latin typeface="Arial" panose="020B0604020202020204" pitchFamily="34" charset="0"/>
                <a:cs typeface="Arial" panose="020B0604020202020204" pitchFamily="34" charset="0"/>
              </a:rPr>
              <a:t>shunt</a:t>
            </a:r>
            <a:endParaRPr lang="de-DE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mpling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≤</a:t>
            </a:r>
            <a:r>
              <a:rPr lang="de-DE" dirty="0"/>
              <a:t> 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nutes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end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HD</a:t>
            </a:r>
          </a:p>
          <a:p>
            <a:pPr algn="ctr"/>
            <a:endParaRPr lang="de-DE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amples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ept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ce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il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zen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at -80</a:t>
            </a:r>
            <a:r>
              <a:rPr lang="en-US" sz="2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°</a:t>
            </a:r>
            <a:r>
              <a:rPr lang="de-DE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pPr marL="285750" indent="-285750" algn="ctr">
              <a:buFont typeface="Symbol" panose="05050102010706020507" pitchFamily="18" charset="2"/>
              <a:buChar char="-"/>
            </a:pPr>
            <a:endParaRPr lang="de-DE" dirty="0"/>
          </a:p>
        </p:txBody>
      </p:sp>
      <p:sp>
        <p:nvSpPr>
          <p:cNvPr id="4" name="Textfeld 3"/>
          <p:cNvSpPr txBox="1"/>
          <p:nvPr/>
        </p:nvSpPr>
        <p:spPr>
          <a:xfrm>
            <a:off x="111714" y="109735"/>
            <a:ext cx="8835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ox 1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52303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1</Words>
  <Application>Microsoft Office PowerPoint</Application>
  <PresentationFormat>Breitbild</PresentationFormat>
  <Paragraphs>35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</vt:lpstr>
      <vt:lpstr>PowerPoint-Präsentation</vt:lpstr>
      <vt:lpstr>PowerPoint-Präsentation</vt:lpstr>
    </vt:vector>
  </TitlesOfParts>
  <Company>Universitätsklinik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amporaki, Christina</dc:creator>
  <cp:lastModifiedBy>Pamporaki, Christina</cp:lastModifiedBy>
  <cp:revision>11</cp:revision>
  <dcterms:created xsi:type="dcterms:W3CDTF">2021-06-06T17:39:25Z</dcterms:created>
  <dcterms:modified xsi:type="dcterms:W3CDTF">2021-06-09T17:25:57Z</dcterms:modified>
</cp:coreProperties>
</file>